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203381-6758-44FD-AF40-5DBBB3F4D1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F99767-F1A6-42B9-AE43-D5796E89DB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DE3171-5863-4D71-9574-78110928D8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F409F9-D1D3-4CE3-94E2-E3CF63314F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D22E5-7CA6-4A83-9607-6FF62D6A0D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5A5095-28A1-48EE-B997-1223AAA918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B19406-029C-4D91-BA8D-47B5423BE1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B21462-4A30-4347-A35E-1F2EA3902E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5FC3F-9DE3-48F5-B5C2-226D4D70F5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42D0D-FC31-42A0-A6CB-66CECCA74C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6F3070-FD7E-4AD5-9F07-5FCE0DA6ED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969E3-8C30-4C93-BC29-8425EE8200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9D783D-CCAE-48ED-90E8-465A4922996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238400" y="762120"/>
            <a:ext cx="4552920" cy="54864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55880" y="304200"/>
            <a:ext cx="670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Figure S11. Direct comparison between maize AR182 and its orthologous sorghum pseudomolecul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15T05:23:06Z</dcterms:created>
  <dc:creator>fushengw</dc:creator>
  <dc:description/>
  <dc:language>en-US</dc:language>
  <cp:lastModifiedBy>fushengw</cp:lastModifiedBy>
  <dcterms:modified xsi:type="dcterms:W3CDTF">2009-10-15T05:25:40Z</dcterms:modified>
  <cp:revision>3</cp:revision>
  <dc:subject/>
  <dc:title>Slide 1</dc:title>
</cp:coreProperties>
</file>